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7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304" userDrawn="1">
          <p15:clr>
            <a:srgbClr val="A4A3A4"/>
          </p15:clr>
        </p15:guide>
        <p15:guide id="3" orient="horz" pos="2653" userDrawn="1">
          <p15:clr>
            <a:srgbClr val="A4A3A4"/>
          </p15:clr>
        </p15:guide>
        <p15:guide id="4" pos="1584" userDrawn="1">
          <p15:clr>
            <a:srgbClr val="A4A3A4"/>
          </p15:clr>
        </p15:guide>
        <p15:guide id="5" orient="horz" pos="4920" userDrawn="1">
          <p15:clr>
            <a:srgbClr val="A4A3A4"/>
          </p15:clr>
        </p15:guide>
        <p15:guide id="7" orient="horz" pos="3168" userDrawn="1">
          <p15:clr>
            <a:srgbClr val="A4A3A4"/>
          </p15:clr>
        </p15:guide>
        <p15:guide id="8" orient="horz" pos="3538" userDrawn="1">
          <p15:clr>
            <a:srgbClr val="A4A3A4"/>
          </p15:clr>
        </p15:guide>
        <p15:guide id="9" orient="horz" pos="4104" userDrawn="1">
          <p15:clr>
            <a:srgbClr val="A4A3A4"/>
          </p15:clr>
        </p15:guide>
        <p15:guide id="11" pos="2908" userDrawn="1">
          <p15:clr>
            <a:srgbClr val="A4A3A4"/>
          </p15:clr>
        </p15:guide>
        <p15:guide id="13" orient="horz" pos="15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Helle Formatvorlage 2 - Akz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8799B23B-EC83-4686-B30A-512413B5E67A}" styleName="Helle Formatvorlage 3 - Akz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4660"/>
  </p:normalViewPr>
  <p:slideViewPr>
    <p:cSldViewPr snapToGrid="0">
      <p:cViewPr varScale="1">
        <p:scale>
          <a:sx n="78" d="100"/>
          <a:sy n="78" d="100"/>
        </p:scale>
        <p:origin x="2369" y="55"/>
      </p:cViewPr>
      <p:guideLst>
        <p:guide orient="horz" pos="2160"/>
        <p:guide pos="2304"/>
        <p:guide orient="horz" pos="2653"/>
        <p:guide pos="1584"/>
        <p:guide orient="horz" pos="4920"/>
        <p:guide orient="horz" pos="3168"/>
        <p:guide orient="horz" pos="3538"/>
        <p:guide orient="horz" pos="4104"/>
        <p:guide pos="2908"/>
        <p:guide orient="horz" pos="15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098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DDFBFE-B4EE-4111-8078-2730EF5F22F0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606" y="4776791"/>
            <a:ext cx="5438464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098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A4A7BC-97C3-4583-8C69-B666DED6E3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81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Lena </a:t>
            </a:r>
            <a:r>
              <a:rPr lang="de-DE" dirty="0" err="1"/>
              <a:t>checked</a:t>
            </a:r>
            <a:r>
              <a:rPr lang="de-DE" dirty="0"/>
              <a:t> and </a:t>
            </a:r>
            <a:r>
              <a:rPr lang="de-DE" dirty="0" err="1"/>
              <a:t>updated</a:t>
            </a:r>
            <a:endParaRPr lang="de-DE" dirty="0"/>
          </a:p>
          <a:p>
            <a:endParaRPr lang="de-DE" dirty="0"/>
          </a:p>
          <a:p>
            <a:r>
              <a:rPr lang="de-DE" dirty="0"/>
              <a:t>A-B    PART_3a_HER2paper_EDI3KD</a:t>
            </a:r>
          </a:p>
          <a:p>
            <a:r>
              <a:rPr lang="en-US" dirty="0"/>
              <a:t>\\storage.ifado.local\HepatoSys\Lena Zak\_</a:t>
            </a:r>
            <a:r>
              <a:rPr lang="en-US" dirty="0" err="1"/>
              <a:t>for_Rosi</a:t>
            </a:r>
            <a:r>
              <a:rPr lang="en-US" dirty="0"/>
              <a:t>\_Experiments\7_EDI3 KD</a:t>
            </a:r>
          </a:p>
          <a:p>
            <a:endParaRPr lang="de-DE" dirty="0"/>
          </a:p>
          <a:p>
            <a:r>
              <a:rPr lang="de-DE" dirty="0"/>
              <a:t>C       PART_6_HER2project_BCCLs+pi_CV_EC50</a:t>
            </a:r>
          </a:p>
          <a:p>
            <a:r>
              <a:rPr lang="en-US" dirty="0"/>
              <a:t>\\storage.ifado.local\HepatoSys\Lena Zak\_</a:t>
            </a:r>
            <a:r>
              <a:rPr lang="en-US" dirty="0" err="1"/>
              <a:t>for_Rosi</a:t>
            </a:r>
            <a:r>
              <a:rPr lang="en-US" dirty="0"/>
              <a:t>\_Experiments\12_BCCLs +pathway inhibitors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E9D713-D41B-4632-8359-19E58DAFCA0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088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855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204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889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81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74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974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563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1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22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906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348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325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png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 flipH="1">
            <a:off x="309049" y="2115313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23827" y="2213563"/>
            <a:ext cx="7457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CC1954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900972" y="2213563"/>
            <a:ext cx="6190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KBR3</a:t>
            </a:r>
          </a:p>
        </p:txBody>
      </p:sp>
      <p:sp>
        <p:nvSpPr>
          <p:cNvPr id="26" name="TextBox 25"/>
          <p:cNvSpPr txBox="1"/>
          <p:nvPr/>
        </p:nvSpPr>
        <p:spPr>
          <a:xfrm flipH="1">
            <a:off x="309049" y="3651932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64528" y="84279"/>
            <a:ext cx="6345448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hibiting EDI3 with dipyridamole, alone or in combination with HER2-targeting therapy, in ER-HER2+ tumors in mice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-D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I3 activity in percent after treatment with dipyridamole at different concentrations in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CC1954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KBR3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T474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FM192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 viability in percent of vehicle control after treatment with different concentrations of dipyridamole in SKBR3, HCC1954, BT474 and EFM192A cells (upper panel) and EC50-values with corresponding 95% confidence intervals (CI) (lower panel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ncentration of dipyridamole in plasma after a single oral dose of 120 mg/kg dipyridamole in mice over time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ouse weight (grams) after treatment with dipyridamole, lapatinib and the combination for up to 4 week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ages of CD1 nude mice with tumors encircled, after 4-week treatment of vehicle, dipyridamole, lapatinib and the combination of both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lasma and tumor concentrations (µM) of dipyridamole (upper panel) and lapatinib (lower panel) after treatment with each compound alone or in combination (D+L). Data (A-E) are mean ± SD of three independent experiments; mean ± SD of three CD1 mice (F); mean ± SD 5 to 6 mice (G); and representative images of 4 mice per condition (H). D+L (combined dipyridamole and lapatinib treatment); BQL (below quantification limit); EC50 (half maximal effective concentration).</a:t>
            </a:r>
          </a:p>
        </p:txBody>
      </p:sp>
      <p:sp>
        <p:nvSpPr>
          <p:cNvPr id="9" name="Rectangle 8"/>
          <p:cNvSpPr/>
          <p:nvPr/>
        </p:nvSpPr>
        <p:spPr>
          <a:xfrm>
            <a:off x="1565925" y="4406822"/>
            <a:ext cx="597502" cy="3277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/>
          <p:cNvSpPr txBox="1"/>
          <p:nvPr/>
        </p:nvSpPr>
        <p:spPr>
          <a:xfrm flipH="1">
            <a:off x="2056577" y="2115313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 flipH="1">
            <a:off x="2056577" y="3651932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012793" y="3756116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T474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830440" y="3756116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FM192A</a:t>
            </a:r>
          </a:p>
        </p:txBody>
      </p:sp>
      <p:sp>
        <p:nvSpPr>
          <p:cNvPr id="44" name="TextBox 43"/>
          <p:cNvSpPr txBox="1"/>
          <p:nvPr/>
        </p:nvSpPr>
        <p:spPr>
          <a:xfrm flipH="1">
            <a:off x="3924584" y="2115313"/>
            <a:ext cx="7330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flipH="1">
            <a:off x="2056577" y="5320035"/>
            <a:ext cx="323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113141" y="5955292"/>
            <a:ext cx="934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/2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= 1.07h</a:t>
            </a:r>
          </a:p>
          <a:p>
            <a:r>
              <a:rPr lang="en-U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6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= 0.25 h</a:t>
            </a:r>
          </a:p>
          <a:p>
            <a:r>
              <a:rPr lang="en-US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6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 = 6059.34 ng/ml</a:t>
            </a:r>
          </a:p>
        </p:txBody>
      </p:sp>
      <p:sp>
        <p:nvSpPr>
          <p:cNvPr id="41" name="TextBox 40"/>
          <p:cNvSpPr txBox="1"/>
          <p:nvPr/>
        </p:nvSpPr>
        <p:spPr>
          <a:xfrm flipH="1">
            <a:off x="309049" y="5320035"/>
            <a:ext cx="323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880895" y="2148574"/>
            <a:ext cx="10855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ipyridamole 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ose response</a:t>
            </a:r>
          </a:p>
        </p:txBody>
      </p:sp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xmlns="" id="{4AF237BA-FFEA-459B-B5EE-9A2E52CCCC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8705119"/>
              </p:ext>
            </p:extLst>
          </p:nvPr>
        </p:nvGraphicFramePr>
        <p:xfrm>
          <a:off x="4272589" y="4662662"/>
          <a:ext cx="2186558" cy="68580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631667">
                  <a:extLst>
                    <a:ext uri="{9D8B030D-6E8A-4147-A177-3AD203B41FA5}">
                      <a16:colId xmlns:a16="http://schemas.microsoft.com/office/drawing/2014/main" xmlns="" val="360781355"/>
                    </a:ext>
                  </a:extLst>
                </a:gridCol>
                <a:gridCol w="659284">
                  <a:extLst>
                    <a:ext uri="{9D8B030D-6E8A-4147-A177-3AD203B41FA5}">
                      <a16:colId xmlns:a16="http://schemas.microsoft.com/office/drawing/2014/main" xmlns="" val="1253719793"/>
                    </a:ext>
                  </a:extLst>
                </a:gridCol>
                <a:gridCol w="895607">
                  <a:extLst>
                    <a:ext uri="{9D8B030D-6E8A-4147-A177-3AD203B41FA5}">
                      <a16:colId xmlns:a16="http://schemas.microsoft.com/office/drawing/2014/main" xmlns="" val="3701803257"/>
                    </a:ext>
                  </a:extLst>
                </a:gridCol>
              </a:tblGrid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line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50 (µM)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93563001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BR3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65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32 – 83.61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16408316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C1954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24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60 – 81.29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62041892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T474</a:t>
                      </a:r>
                      <a:endParaRPr lang="de-DE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.00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.30 – 289.00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0269870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M192A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.80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.70 – 286.50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13785240"/>
                  </a:ext>
                </a:extLst>
              </a:tr>
            </a:tbl>
          </a:graphicData>
        </a:graphic>
      </p:graphicFrame>
      <p:sp>
        <p:nvSpPr>
          <p:cNvPr id="42" name="TextBox 41"/>
          <p:cNvSpPr txBox="1"/>
          <p:nvPr/>
        </p:nvSpPr>
        <p:spPr>
          <a:xfrm flipH="1">
            <a:off x="309049" y="6898996"/>
            <a:ext cx="323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3"/>
          <a:srcRect r="42129"/>
          <a:stretch/>
        </p:blipFill>
        <p:spPr>
          <a:xfrm rot="16200000">
            <a:off x="1418214" y="6448855"/>
            <a:ext cx="1778926" cy="3113168"/>
          </a:xfrm>
          <a:prstGeom prst="rect">
            <a:avLst/>
          </a:prstGeom>
        </p:spPr>
      </p:pic>
      <p:sp>
        <p:nvSpPr>
          <p:cNvPr id="32" name="TextBox 37">
            <a:extLst>
              <a:ext uri="{FF2B5EF4-FFF2-40B4-BE49-F238E27FC236}">
                <a16:creationId xmlns:a16="http://schemas.microsoft.com/office/drawing/2014/main" xmlns="" id="{8C603393-FB7B-4042-80FF-F5630282D046}"/>
              </a:ext>
            </a:extLst>
          </p:cNvPr>
          <p:cNvSpPr txBox="1"/>
          <p:nvPr/>
        </p:nvSpPr>
        <p:spPr>
          <a:xfrm>
            <a:off x="893168" y="6933288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43" name="TextBox 37">
            <a:extLst>
              <a:ext uri="{FF2B5EF4-FFF2-40B4-BE49-F238E27FC236}">
                <a16:creationId xmlns:a16="http://schemas.microsoft.com/office/drawing/2014/main" xmlns="" id="{5FCE12C9-C004-4EB0-8054-5D15265ED2FB}"/>
              </a:ext>
            </a:extLst>
          </p:cNvPr>
          <p:cNvSpPr txBox="1"/>
          <p:nvPr/>
        </p:nvSpPr>
        <p:spPr>
          <a:xfrm>
            <a:off x="1613265" y="6933288"/>
            <a:ext cx="60465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patinib</a:t>
            </a:r>
          </a:p>
        </p:txBody>
      </p:sp>
      <p:sp>
        <p:nvSpPr>
          <p:cNvPr id="46" name="TextBox 37">
            <a:extLst>
              <a:ext uri="{FF2B5EF4-FFF2-40B4-BE49-F238E27FC236}">
                <a16:creationId xmlns:a16="http://schemas.microsoft.com/office/drawing/2014/main" xmlns="" id="{413F92F7-7E3B-43E9-A824-2C1659D87C5F}"/>
              </a:ext>
            </a:extLst>
          </p:cNvPr>
          <p:cNvSpPr txBox="1"/>
          <p:nvPr/>
        </p:nvSpPr>
        <p:spPr>
          <a:xfrm>
            <a:off x="2282277" y="6933288"/>
            <a:ext cx="7841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ipyridamole</a:t>
            </a:r>
          </a:p>
        </p:txBody>
      </p:sp>
      <p:sp>
        <p:nvSpPr>
          <p:cNvPr id="47" name="TextBox 37">
            <a:extLst>
              <a:ext uri="{FF2B5EF4-FFF2-40B4-BE49-F238E27FC236}">
                <a16:creationId xmlns:a16="http://schemas.microsoft.com/office/drawing/2014/main" xmlns="" id="{1700433D-2068-4D34-BBFE-97FFB8A76B15}"/>
              </a:ext>
            </a:extLst>
          </p:cNvPr>
          <p:cNvSpPr txBox="1"/>
          <p:nvPr/>
        </p:nvSpPr>
        <p:spPr>
          <a:xfrm>
            <a:off x="3049049" y="6810178"/>
            <a:ext cx="7681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patinib &amp;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pyridamol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Tabelle 12">
            <a:extLst>
              <a:ext uri="{FF2B5EF4-FFF2-40B4-BE49-F238E27FC236}">
                <a16:creationId xmlns:a16="http://schemas.microsoft.com/office/drawing/2014/main" xmlns="" id="{1117E58D-EDA5-4E03-80ED-167F635D767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6449116"/>
              </p:ext>
            </p:extLst>
          </p:nvPr>
        </p:nvGraphicFramePr>
        <p:xfrm>
          <a:off x="4190641" y="5613561"/>
          <a:ext cx="2366010" cy="97663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805792">
                  <a:extLst>
                    <a:ext uri="{9D8B030D-6E8A-4147-A177-3AD203B41FA5}">
                      <a16:colId xmlns:a16="http://schemas.microsoft.com/office/drawing/2014/main" xmlns="" val="4164503096"/>
                    </a:ext>
                  </a:extLst>
                </a:gridCol>
                <a:gridCol w="780109">
                  <a:extLst>
                    <a:ext uri="{9D8B030D-6E8A-4147-A177-3AD203B41FA5}">
                      <a16:colId xmlns:a16="http://schemas.microsoft.com/office/drawing/2014/main" xmlns="" val="4193296520"/>
                    </a:ext>
                  </a:extLst>
                </a:gridCol>
                <a:gridCol w="780109">
                  <a:extLst>
                    <a:ext uri="{9D8B030D-6E8A-4147-A177-3AD203B41FA5}">
                      <a16:colId xmlns:a16="http://schemas.microsoft.com/office/drawing/2014/main" xmlns="" val="1398857603"/>
                    </a:ext>
                  </a:extLst>
                </a:gridCol>
              </a:tblGrid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pyridamole</a:t>
                      </a:r>
                      <a:endParaRPr lang="de-DE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63332263"/>
                  </a:ext>
                </a:extLst>
              </a:tr>
              <a:tr h="29083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conc. (µM)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conc. (µM)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60205306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pyridamole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5 ± 1.96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 ± 0.40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22783189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patinib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0681285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L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4 ± 1.80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 ± 0.16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44329375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39295322"/>
                  </a:ext>
                </a:extLst>
              </a:tr>
            </a:tbl>
          </a:graphicData>
        </a:graphic>
      </p:graphicFrame>
      <p:graphicFrame>
        <p:nvGraphicFramePr>
          <p:cNvPr id="17" name="Tabelle 16">
            <a:extLst>
              <a:ext uri="{FF2B5EF4-FFF2-40B4-BE49-F238E27FC236}">
                <a16:creationId xmlns:a16="http://schemas.microsoft.com/office/drawing/2014/main" xmlns="" id="{092A9C4F-B9DA-48C6-8B9A-B80BE5737C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1025153"/>
              </p:ext>
            </p:extLst>
          </p:nvPr>
        </p:nvGraphicFramePr>
        <p:xfrm>
          <a:off x="4197521" y="6772705"/>
          <a:ext cx="2366010" cy="976630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805792">
                  <a:extLst>
                    <a:ext uri="{9D8B030D-6E8A-4147-A177-3AD203B41FA5}">
                      <a16:colId xmlns:a16="http://schemas.microsoft.com/office/drawing/2014/main" xmlns="" val="3696759548"/>
                    </a:ext>
                  </a:extLst>
                </a:gridCol>
                <a:gridCol w="780109">
                  <a:extLst>
                    <a:ext uri="{9D8B030D-6E8A-4147-A177-3AD203B41FA5}">
                      <a16:colId xmlns:a16="http://schemas.microsoft.com/office/drawing/2014/main" xmlns="" val="731395803"/>
                    </a:ext>
                  </a:extLst>
                </a:gridCol>
                <a:gridCol w="780109">
                  <a:extLst>
                    <a:ext uri="{9D8B030D-6E8A-4147-A177-3AD203B41FA5}">
                      <a16:colId xmlns:a16="http://schemas.microsoft.com/office/drawing/2014/main" xmlns="" val="1381588737"/>
                    </a:ext>
                  </a:extLst>
                </a:gridCol>
              </a:tblGrid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 </a:t>
                      </a: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patinib</a:t>
                      </a:r>
                      <a:endParaRPr lang="de-DE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63209509"/>
                  </a:ext>
                </a:extLst>
              </a:tr>
              <a:tr h="29083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ound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conc. (µM)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conc. (µM)</a:t>
                      </a:r>
                      <a:endParaRPr lang="de-DE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37230388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pyridamole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99365315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patinib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9 ± 1.95</a:t>
                      </a:r>
                      <a:endParaRPr lang="de-DE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1.95 ± 0.31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234311194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r>
                        <a:rPr lang="de-DE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L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4 ± 1.46</a:t>
                      </a:r>
                      <a:endParaRPr lang="de-DE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5 ± 2.47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07175580"/>
                  </a:ext>
                </a:extLst>
              </a:tr>
              <a:tr h="13716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de-DE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QL</a:t>
                      </a:r>
                      <a:endParaRPr lang="de-DE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47771972"/>
                  </a:ext>
                </a:extLst>
              </a:tr>
            </a:tbl>
          </a:graphicData>
        </a:graphic>
      </p:graphicFrame>
      <p:sp>
        <p:nvSpPr>
          <p:cNvPr id="49" name="TextBox 41">
            <a:extLst>
              <a:ext uri="{FF2B5EF4-FFF2-40B4-BE49-F238E27FC236}">
                <a16:creationId xmlns:a16="http://schemas.microsoft.com/office/drawing/2014/main" xmlns="" id="{E6166AF1-7287-4019-B5E2-F4C6DEC93CC5}"/>
              </a:ext>
            </a:extLst>
          </p:cNvPr>
          <p:cNvSpPr txBox="1"/>
          <p:nvPr/>
        </p:nvSpPr>
        <p:spPr>
          <a:xfrm flipH="1">
            <a:off x="3849806" y="5447035"/>
            <a:ext cx="3231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28" name="Grafik 27">
            <a:extLst>
              <a:ext uri="{FF2B5EF4-FFF2-40B4-BE49-F238E27FC236}">
                <a16:creationId xmlns:a16="http://schemas.microsoft.com/office/drawing/2014/main" xmlns="" id="{4F59A368-F9A4-4D3A-3798-D8E2EC2228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792" y="5371771"/>
            <a:ext cx="1879600" cy="14605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72589" y="2353110"/>
            <a:ext cx="2144784" cy="2286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5157" y="2247134"/>
            <a:ext cx="1687985" cy="154533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1150" y="3835632"/>
            <a:ext cx="1687985" cy="154533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43345" y="3833803"/>
            <a:ext cx="1687985" cy="1545336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50862" y="2268068"/>
            <a:ext cx="1648033" cy="150876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204917" y="5405807"/>
            <a:ext cx="1828125" cy="1426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0350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25</Words>
  <Application>Microsoft Office PowerPoint</Application>
  <PresentationFormat>On-screen Show (4:3)</PresentationFormat>
  <Paragraphs>8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olina Edlund</dc:creator>
  <cp:lastModifiedBy>Marchan Rosemarie</cp:lastModifiedBy>
  <cp:revision>280</cp:revision>
  <cp:lastPrinted>2021-11-12T17:42:16Z</cp:lastPrinted>
  <dcterms:created xsi:type="dcterms:W3CDTF">2020-02-28T15:51:27Z</dcterms:created>
  <dcterms:modified xsi:type="dcterms:W3CDTF">2023-01-06T12:54:08Z</dcterms:modified>
</cp:coreProperties>
</file>